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6" d="100"/>
          <a:sy n="106" d="100"/>
        </p:scale>
        <p:origin x="150" y="10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pril\Desktop\CCNE1%20and%20E2F1%20exp%20in%20GEPI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pril\Desktop\CCNE1%20and%20E2F1%20exp%20in%20GEPI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CCNE1!$A$2:$A$32</c:f>
              <c:strCache>
                <c:ptCount val="31"/>
                <c:pt idx="0">
                  <c:v>UCS</c:v>
                </c:pt>
                <c:pt idx="1">
                  <c:v>DLBC</c:v>
                </c:pt>
                <c:pt idx="2">
                  <c:v>UCEC</c:v>
                </c:pt>
                <c:pt idx="3">
                  <c:v>CHOL</c:v>
                </c:pt>
                <c:pt idx="4">
                  <c:v>OV</c:v>
                </c:pt>
                <c:pt idx="5">
                  <c:v>THYM</c:v>
                </c:pt>
                <c:pt idx="6">
                  <c:v>CESC</c:v>
                </c:pt>
                <c:pt idx="7">
                  <c:v>LUSC</c:v>
                </c:pt>
                <c:pt idx="8">
                  <c:v>LIHC</c:v>
                </c:pt>
                <c:pt idx="9">
                  <c:v>PAAD</c:v>
                </c:pt>
                <c:pt idx="10">
                  <c:v>STAD</c:v>
                </c:pt>
                <c:pt idx="11">
                  <c:v>SARC</c:v>
                </c:pt>
                <c:pt idx="12">
                  <c:v>BLCA</c:v>
                </c:pt>
                <c:pt idx="13">
                  <c:v>LUAD</c:v>
                </c:pt>
                <c:pt idx="14">
                  <c:v>HNSC</c:v>
                </c:pt>
                <c:pt idx="15">
                  <c:v>BRCA</c:v>
                </c:pt>
                <c:pt idx="16">
                  <c:v>ACC</c:v>
                </c:pt>
                <c:pt idx="17">
                  <c:v>COAD</c:v>
                </c:pt>
                <c:pt idx="18">
                  <c:v>READ</c:v>
                </c:pt>
                <c:pt idx="19">
                  <c:v>ESCA</c:v>
                </c:pt>
                <c:pt idx="20">
                  <c:v>KIRP</c:v>
                </c:pt>
                <c:pt idx="21">
                  <c:v>SKCM</c:v>
                </c:pt>
                <c:pt idx="22">
                  <c:v>KICH</c:v>
                </c:pt>
                <c:pt idx="23">
                  <c:v>GBM</c:v>
                </c:pt>
                <c:pt idx="24">
                  <c:v>KIRC</c:v>
                </c:pt>
                <c:pt idx="25">
                  <c:v>THCA</c:v>
                </c:pt>
                <c:pt idx="26">
                  <c:v>TGCT</c:v>
                </c:pt>
                <c:pt idx="27">
                  <c:v>LGG</c:v>
                </c:pt>
                <c:pt idx="28">
                  <c:v>PRAD</c:v>
                </c:pt>
                <c:pt idx="29">
                  <c:v>PCPG</c:v>
                </c:pt>
                <c:pt idx="30">
                  <c:v>LAML</c:v>
                </c:pt>
              </c:strCache>
            </c:strRef>
          </c:cat>
          <c:val>
            <c:numRef>
              <c:f>CCNE1!$D$2:$D$32</c:f>
              <c:numCache>
                <c:formatCode>0.00_ </c:formatCode>
                <c:ptCount val="31"/>
                <c:pt idx="0">
                  <c:v>45.162162162162168</c:v>
                </c:pt>
                <c:pt idx="1">
                  <c:v>43.903225806451609</c:v>
                </c:pt>
                <c:pt idx="2">
                  <c:v>30.076923076923077</c:v>
                </c:pt>
                <c:pt idx="3">
                  <c:v>28.611111111111114</c:v>
                </c:pt>
                <c:pt idx="4">
                  <c:v>24.630952380952383</c:v>
                </c:pt>
                <c:pt idx="5">
                  <c:v>18.939393939393938</c:v>
                </c:pt>
                <c:pt idx="6">
                  <c:v>17.564102564102562</c:v>
                </c:pt>
                <c:pt idx="7">
                  <c:v>7.330578512396694</c:v>
                </c:pt>
                <c:pt idx="8">
                  <c:v>7.0454545454545459</c:v>
                </c:pt>
                <c:pt idx="9">
                  <c:v>6.3684210526315796</c:v>
                </c:pt>
                <c:pt idx="10">
                  <c:v>5.1526717557251906</c:v>
                </c:pt>
                <c:pt idx="11">
                  <c:v>4.7333333333333334</c:v>
                </c:pt>
                <c:pt idx="12">
                  <c:v>4.6792452830188678</c:v>
                </c:pt>
                <c:pt idx="13">
                  <c:v>3.3781512605042017</c:v>
                </c:pt>
                <c:pt idx="14">
                  <c:v>3.339285714285714</c:v>
                </c:pt>
                <c:pt idx="15">
                  <c:v>3.333333333333333</c:v>
                </c:pt>
                <c:pt idx="16">
                  <c:v>2.9965635738831615</c:v>
                </c:pt>
                <c:pt idx="17">
                  <c:v>2.808080808080808</c:v>
                </c:pt>
                <c:pt idx="18">
                  <c:v>2.6843853820598009</c:v>
                </c:pt>
                <c:pt idx="19">
                  <c:v>2.3762626262626263</c:v>
                </c:pt>
                <c:pt idx="20">
                  <c:v>2.0422535211267605</c:v>
                </c:pt>
                <c:pt idx="21">
                  <c:v>1.8668478260869565</c:v>
                </c:pt>
                <c:pt idx="22">
                  <c:v>1.5157894736842106</c:v>
                </c:pt>
                <c:pt idx="23">
                  <c:v>1.4565916398713827</c:v>
                </c:pt>
                <c:pt idx="24">
                  <c:v>1.3766233766233766</c:v>
                </c:pt>
                <c:pt idx="25">
                  <c:v>0.90697674418604657</c:v>
                </c:pt>
                <c:pt idx="26">
                  <c:v>0.87416538263995891</c:v>
                </c:pt>
                <c:pt idx="27">
                  <c:v>0.81672025723472674</c:v>
                </c:pt>
                <c:pt idx="28">
                  <c:v>0.80303030303030298</c:v>
                </c:pt>
                <c:pt idx="29">
                  <c:v>0.79824561403508776</c:v>
                </c:pt>
                <c:pt idx="30">
                  <c:v>0.58709308966304963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251747112"/>
        <c:axId val="439772016"/>
      </c:barChart>
      <c:catAx>
        <c:axId val="251747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cap="all" spc="12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439772016"/>
        <c:crosses val="autoZero"/>
        <c:auto val="1"/>
        <c:lblAlgn val="ctr"/>
        <c:lblOffset val="100"/>
        <c:noMultiLvlLbl val="0"/>
      </c:catAx>
      <c:valAx>
        <c:axId val="4397720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_ 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517471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E2F1!$A$2:$A$32</c:f>
              <c:strCache>
                <c:ptCount val="31"/>
                <c:pt idx="0">
                  <c:v>CHOL</c:v>
                </c:pt>
                <c:pt idx="1">
                  <c:v>DLBC</c:v>
                </c:pt>
                <c:pt idx="2">
                  <c:v>LIHC</c:v>
                </c:pt>
                <c:pt idx="3">
                  <c:v>CESC</c:v>
                </c:pt>
                <c:pt idx="4">
                  <c:v>UCS</c:v>
                </c:pt>
                <c:pt idx="5">
                  <c:v>PAAD</c:v>
                </c:pt>
                <c:pt idx="6">
                  <c:v>UCEC</c:v>
                </c:pt>
                <c:pt idx="7">
                  <c:v>THYM</c:v>
                </c:pt>
                <c:pt idx="8">
                  <c:v>SARC</c:v>
                </c:pt>
                <c:pt idx="9">
                  <c:v>READ</c:v>
                </c:pt>
                <c:pt idx="10">
                  <c:v>KICH</c:v>
                </c:pt>
                <c:pt idx="11">
                  <c:v>COAD</c:v>
                </c:pt>
                <c:pt idx="12">
                  <c:v>BLCA</c:v>
                </c:pt>
                <c:pt idx="13">
                  <c:v>BRCA</c:v>
                </c:pt>
                <c:pt idx="14">
                  <c:v>KIRP</c:v>
                </c:pt>
                <c:pt idx="15">
                  <c:v>STAD</c:v>
                </c:pt>
                <c:pt idx="16">
                  <c:v>KIRC</c:v>
                </c:pt>
                <c:pt idx="17">
                  <c:v>OV</c:v>
                </c:pt>
                <c:pt idx="18">
                  <c:v>THCA</c:v>
                </c:pt>
                <c:pt idx="19">
                  <c:v>SKCM</c:v>
                </c:pt>
                <c:pt idx="20">
                  <c:v>HNSC</c:v>
                </c:pt>
                <c:pt idx="21">
                  <c:v>LUSC</c:v>
                </c:pt>
                <c:pt idx="22">
                  <c:v>ESCA</c:v>
                </c:pt>
                <c:pt idx="23">
                  <c:v>ACC</c:v>
                </c:pt>
                <c:pt idx="24">
                  <c:v>GBM</c:v>
                </c:pt>
                <c:pt idx="25">
                  <c:v>LUAD</c:v>
                </c:pt>
                <c:pt idx="26">
                  <c:v>TGCT</c:v>
                </c:pt>
                <c:pt idx="27">
                  <c:v>LAML</c:v>
                </c:pt>
                <c:pt idx="28">
                  <c:v>PRAD</c:v>
                </c:pt>
                <c:pt idx="29">
                  <c:v>LGG</c:v>
                </c:pt>
                <c:pt idx="30">
                  <c:v>PCPG</c:v>
                </c:pt>
              </c:strCache>
            </c:strRef>
          </c:cat>
          <c:val>
            <c:numRef>
              <c:f>E2F1!$D$2:$D$32</c:f>
              <c:numCache>
                <c:formatCode>0.00_ </c:formatCode>
                <c:ptCount val="31"/>
                <c:pt idx="0">
                  <c:v>41.454545454545453</c:v>
                </c:pt>
                <c:pt idx="1">
                  <c:v>21.245454545454546</c:v>
                </c:pt>
                <c:pt idx="2">
                  <c:v>19.607142857142858</c:v>
                </c:pt>
                <c:pt idx="3">
                  <c:v>18.420634920634921</c:v>
                </c:pt>
                <c:pt idx="4">
                  <c:v>17.945454545454542</c:v>
                </c:pt>
                <c:pt idx="5">
                  <c:v>15.321428571428569</c:v>
                </c:pt>
                <c:pt idx="6">
                  <c:v>12.669642857142856</c:v>
                </c:pt>
                <c:pt idx="7">
                  <c:v>11.17272727272727</c:v>
                </c:pt>
                <c:pt idx="8">
                  <c:v>7.7550335570469802</c:v>
                </c:pt>
                <c:pt idx="9">
                  <c:v>7.6169154228855733</c:v>
                </c:pt>
                <c:pt idx="10">
                  <c:v>6.6190476190476186</c:v>
                </c:pt>
                <c:pt idx="11">
                  <c:v>6.342723004694836</c:v>
                </c:pt>
                <c:pt idx="12">
                  <c:v>6.3316062176165806</c:v>
                </c:pt>
                <c:pt idx="13">
                  <c:v>6.3125</c:v>
                </c:pt>
                <c:pt idx="14">
                  <c:v>5.6666666666666661</c:v>
                </c:pt>
                <c:pt idx="15">
                  <c:v>5.172774869109948</c:v>
                </c:pt>
                <c:pt idx="16">
                  <c:v>5.0377358490566033</c:v>
                </c:pt>
                <c:pt idx="17">
                  <c:v>4.9936908517350158</c:v>
                </c:pt>
                <c:pt idx="18">
                  <c:v>4.6292134831460672</c:v>
                </c:pt>
                <c:pt idx="19">
                  <c:v>4.4834254143646408</c:v>
                </c:pt>
                <c:pt idx="20">
                  <c:v>3.6440677966101696</c:v>
                </c:pt>
                <c:pt idx="21">
                  <c:v>3.4407294832826749</c:v>
                </c:pt>
                <c:pt idx="22">
                  <c:v>3.081841432225064</c:v>
                </c:pt>
                <c:pt idx="23">
                  <c:v>2.8014888337468977</c:v>
                </c:pt>
                <c:pt idx="24">
                  <c:v>2.53125</c:v>
                </c:pt>
                <c:pt idx="25">
                  <c:v>2.4524495677233427</c:v>
                </c:pt>
                <c:pt idx="26">
                  <c:v>1.684055841293167</c:v>
                </c:pt>
                <c:pt idx="27">
                  <c:v>1.2623985572587917</c:v>
                </c:pt>
                <c:pt idx="28">
                  <c:v>1.1436464088397789</c:v>
                </c:pt>
                <c:pt idx="29">
                  <c:v>1.041015625</c:v>
                </c:pt>
                <c:pt idx="30">
                  <c:v>0.78762886597938142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441962336"/>
        <c:axId val="441967432"/>
      </c:barChart>
      <c:catAx>
        <c:axId val="441962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cap="all" spc="12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441967432"/>
        <c:crosses val="autoZero"/>
        <c:auto val="1"/>
        <c:lblAlgn val="ctr"/>
        <c:lblOffset val="100"/>
        <c:noMultiLvlLbl val="0"/>
      </c:catAx>
      <c:valAx>
        <c:axId val="4419674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_ 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441962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800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800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687E-221D-4937-A2FB-C8EB7D4ED621}" type="datetimeFigureOut">
              <a:rPr lang="zh-CN" altLang="en-US" smtClean="0"/>
              <a:t>2020/12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C19D3-CE68-4DE5-832A-0886D2EFFF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3464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687E-221D-4937-A2FB-C8EB7D4ED621}" type="datetimeFigureOut">
              <a:rPr lang="zh-CN" altLang="en-US" smtClean="0"/>
              <a:t>2020/12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C19D3-CE68-4DE5-832A-0886D2EFFF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14273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687E-221D-4937-A2FB-C8EB7D4ED621}" type="datetimeFigureOut">
              <a:rPr lang="zh-CN" altLang="en-US" smtClean="0"/>
              <a:t>2020/12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C19D3-CE68-4DE5-832A-0886D2EFFF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8484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687E-221D-4937-A2FB-C8EB7D4ED621}" type="datetimeFigureOut">
              <a:rPr lang="zh-CN" altLang="en-US" smtClean="0"/>
              <a:t>2020/12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C19D3-CE68-4DE5-832A-0886D2EFFF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2625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687E-221D-4937-A2FB-C8EB7D4ED621}" type="datetimeFigureOut">
              <a:rPr lang="zh-CN" altLang="en-US" smtClean="0"/>
              <a:t>2020/12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C19D3-CE68-4DE5-832A-0886D2EFFF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2458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687E-221D-4937-A2FB-C8EB7D4ED621}" type="datetimeFigureOut">
              <a:rPr lang="zh-CN" altLang="en-US" smtClean="0"/>
              <a:t>2020/12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C19D3-CE68-4DE5-832A-0886D2EFFF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8288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687E-221D-4937-A2FB-C8EB7D4ED621}" type="datetimeFigureOut">
              <a:rPr lang="zh-CN" altLang="en-US" smtClean="0"/>
              <a:t>2020/12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C19D3-CE68-4DE5-832A-0886D2EFFF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5099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687E-221D-4937-A2FB-C8EB7D4ED621}" type="datetimeFigureOut">
              <a:rPr lang="zh-CN" altLang="en-US" smtClean="0"/>
              <a:t>2020/12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C19D3-CE68-4DE5-832A-0886D2EFFF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6374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687E-221D-4937-A2FB-C8EB7D4ED621}" type="datetimeFigureOut">
              <a:rPr lang="zh-CN" altLang="en-US" smtClean="0"/>
              <a:t>2020/12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C19D3-CE68-4DE5-832A-0886D2EFFF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3335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687E-221D-4937-A2FB-C8EB7D4ED621}" type="datetimeFigureOut">
              <a:rPr lang="zh-CN" altLang="en-US" smtClean="0"/>
              <a:t>2020/12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C19D3-CE68-4DE5-832A-0886D2EFFF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9481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687E-221D-4937-A2FB-C8EB7D4ED621}" type="datetimeFigureOut">
              <a:rPr lang="zh-CN" altLang="en-US" smtClean="0"/>
              <a:t>2020/12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C19D3-CE68-4DE5-832A-0886D2EFFF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0907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7B687E-221D-4937-A2FB-C8EB7D4ED621}" type="datetimeFigureOut">
              <a:rPr lang="zh-CN" altLang="en-US" smtClean="0"/>
              <a:t>2020/12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EC19D3-CE68-4DE5-832A-0886D2EFFF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3399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2562273"/>
              </p:ext>
            </p:extLst>
          </p:nvPr>
        </p:nvGraphicFramePr>
        <p:xfrm>
          <a:off x="962685" y="745143"/>
          <a:ext cx="7004364" cy="46434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文本框 4"/>
          <p:cNvSpPr txBox="1"/>
          <p:nvPr/>
        </p:nvSpPr>
        <p:spPr>
          <a:xfrm rot="16200000">
            <a:off x="-941298" y="2797522"/>
            <a:ext cx="3438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old change (Tumor/Normal, TPM)</a:t>
            </a:r>
            <a:endParaRPr lang="zh-CN" altLang="en-US" dirty="0"/>
          </a:p>
        </p:txBody>
      </p:sp>
      <p:sp>
        <p:nvSpPr>
          <p:cNvPr id="6" name="文本框 5"/>
          <p:cNvSpPr txBox="1"/>
          <p:nvPr/>
        </p:nvSpPr>
        <p:spPr>
          <a:xfrm>
            <a:off x="4059948" y="375811"/>
            <a:ext cx="8098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 smtClean="0"/>
              <a:t>CCNE1</a:t>
            </a:r>
            <a:endParaRPr lang="zh-CN" altLang="en-US" i="1" dirty="0"/>
          </a:p>
        </p:txBody>
      </p:sp>
      <p:sp>
        <p:nvSpPr>
          <p:cNvPr id="8" name="矩形 7"/>
          <p:cNvSpPr/>
          <p:nvPr/>
        </p:nvSpPr>
        <p:spPr>
          <a:xfrm>
            <a:off x="8183417" y="1233597"/>
            <a:ext cx="5879631" cy="4154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00" dirty="0" smtClean="0"/>
              <a:t>ACC	Adrenocortical carcinoma</a:t>
            </a:r>
          </a:p>
          <a:p>
            <a:r>
              <a:rPr lang="en-US" altLang="zh-CN" sz="800" dirty="0" smtClean="0"/>
              <a:t>BLCA	Bladder Urothelial Carcinoma</a:t>
            </a:r>
          </a:p>
          <a:p>
            <a:r>
              <a:rPr lang="en-US" altLang="zh-CN" sz="800" dirty="0" smtClean="0"/>
              <a:t>BRCA	Breast invasive carcinoma</a:t>
            </a:r>
          </a:p>
          <a:p>
            <a:r>
              <a:rPr lang="en-US" altLang="zh-CN" sz="800" dirty="0" smtClean="0"/>
              <a:t>CESC	Cervical squamous cell carcinoma and </a:t>
            </a:r>
            <a:r>
              <a:rPr lang="en-US" altLang="zh-CN" sz="800" dirty="0" err="1" smtClean="0"/>
              <a:t>endocervical</a:t>
            </a:r>
            <a:r>
              <a:rPr lang="en-US" altLang="zh-CN" sz="800" dirty="0" smtClean="0"/>
              <a:t> adenocarcinoma</a:t>
            </a:r>
          </a:p>
          <a:p>
            <a:r>
              <a:rPr lang="en-US" altLang="zh-CN" sz="800" dirty="0" smtClean="0"/>
              <a:t>CHOL	</a:t>
            </a:r>
            <a:r>
              <a:rPr lang="en-US" altLang="zh-CN" sz="800" dirty="0" err="1" smtClean="0"/>
              <a:t>Cholangio</a:t>
            </a:r>
            <a:r>
              <a:rPr lang="en-US" altLang="zh-CN" sz="800" dirty="0" smtClean="0"/>
              <a:t> carcinoma</a:t>
            </a:r>
          </a:p>
          <a:p>
            <a:r>
              <a:rPr lang="en-US" altLang="zh-CN" sz="800" dirty="0" smtClean="0"/>
              <a:t>COAD	Colon adenocarcinoma</a:t>
            </a:r>
          </a:p>
          <a:p>
            <a:r>
              <a:rPr lang="en-US" altLang="zh-CN" sz="800" dirty="0" smtClean="0"/>
              <a:t>DLBC	Lymphoid Neoplasm Diffuse Large B-cell Lymphoma</a:t>
            </a:r>
          </a:p>
          <a:p>
            <a:r>
              <a:rPr lang="en-US" altLang="zh-CN" sz="800" dirty="0" smtClean="0"/>
              <a:t>ESCA	Esophageal carcinoma</a:t>
            </a:r>
          </a:p>
          <a:p>
            <a:r>
              <a:rPr lang="en-US" altLang="zh-CN" sz="800" dirty="0" smtClean="0"/>
              <a:t>GBM	Glioblastoma </a:t>
            </a:r>
            <a:r>
              <a:rPr lang="en-US" altLang="zh-CN" sz="800" dirty="0" err="1" smtClean="0"/>
              <a:t>multiforme</a:t>
            </a:r>
            <a:endParaRPr lang="en-US" altLang="zh-CN" sz="800" dirty="0" smtClean="0"/>
          </a:p>
          <a:p>
            <a:r>
              <a:rPr lang="en-US" altLang="zh-CN" sz="800" dirty="0" smtClean="0"/>
              <a:t>HNSC	Head and Neck squamous cell carcinoma</a:t>
            </a:r>
          </a:p>
          <a:p>
            <a:r>
              <a:rPr lang="en-US" altLang="zh-CN" sz="800" dirty="0" smtClean="0"/>
              <a:t>KICH	Kidney </a:t>
            </a:r>
            <a:r>
              <a:rPr lang="en-US" altLang="zh-CN" sz="800" dirty="0" err="1" smtClean="0"/>
              <a:t>Chromophobe</a:t>
            </a:r>
            <a:endParaRPr lang="en-US" altLang="zh-CN" sz="800" dirty="0" smtClean="0"/>
          </a:p>
          <a:p>
            <a:r>
              <a:rPr lang="en-US" altLang="zh-CN" sz="800" dirty="0" smtClean="0"/>
              <a:t>KIRC	Kidney renal clear cell carcinoma</a:t>
            </a:r>
          </a:p>
          <a:p>
            <a:r>
              <a:rPr lang="en-US" altLang="zh-CN" sz="800" dirty="0" smtClean="0"/>
              <a:t>KIRP	Kidney renal papillary cell carcinoma</a:t>
            </a:r>
          </a:p>
          <a:p>
            <a:r>
              <a:rPr lang="en-US" altLang="zh-CN" sz="800" dirty="0" smtClean="0"/>
              <a:t>LAML	Acute Myeloid Leukemia</a:t>
            </a:r>
          </a:p>
          <a:p>
            <a:r>
              <a:rPr lang="en-US" altLang="zh-CN" sz="800" dirty="0" smtClean="0"/>
              <a:t>LGG	Brain Lower Grade Glioma</a:t>
            </a:r>
          </a:p>
          <a:p>
            <a:r>
              <a:rPr lang="en-US" altLang="zh-CN" sz="800" dirty="0" smtClean="0"/>
              <a:t>LIHC	Liver hepatocellular carcinoma</a:t>
            </a:r>
          </a:p>
          <a:p>
            <a:r>
              <a:rPr lang="en-US" altLang="zh-CN" sz="800" dirty="0" smtClean="0"/>
              <a:t>LUAD	Lung adenocarcinoma</a:t>
            </a:r>
          </a:p>
          <a:p>
            <a:r>
              <a:rPr lang="en-US" altLang="zh-CN" sz="800" dirty="0" smtClean="0"/>
              <a:t>LUSC	Lung squamous cell carcinoma</a:t>
            </a:r>
          </a:p>
          <a:p>
            <a:r>
              <a:rPr lang="en-US" altLang="zh-CN" sz="800" dirty="0" smtClean="0"/>
              <a:t>MESO	Mesothelioma</a:t>
            </a:r>
          </a:p>
          <a:p>
            <a:r>
              <a:rPr lang="en-US" altLang="zh-CN" sz="800" dirty="0" smtClean="0"/>
              <a:t>OV	Ovarian serous cystadenocarcinoma</a:t>
            </a:r>
          </a:p>
          <a:p>
            <a:r>
              <a:rPr lang="en-US" altLang="zh-CN" sz="800" dirty="0" smtClean="0"/>
              <a:t>PAAD	Pancreatic adenocarcinoma</a:t>
            </a:r>
          </a:p>
          <a:p>
            <a:r>
              <a:rPr lang="en-US" altLang="zh-CN" sz="800" dirty="0" smtClean="0"/>
              <a:t>PCPG	</a:t>
            </a:r>
            <a:r>
              <a:rPr lang="en-US" altLang="zh-CN" sz="800" dirty="0" err="1" smtClean="0"/>
              <a:t>Pheochromocytoma</a:t>
            </a:r>
            <a:r>
              <a:rPr lang="en-US" altLang="zh-CN" sz="800" dirty="0" smtClean="0"/>
              <a:t> and </a:t>
            </a:r>
            <a:r>
              <a:rPr lang="en-US" altLang="zh-CN" sz="800" dirty="0" err="1" smtClean="0"/>
              <a:t>Paraganglioma</a:t>
            </a:r>
            <a:endParaRPr lang="en-US" altLang="zh-CN" sz="800" dirty="0" smtClean="0"/>
          </a:p>
          <a:p>
            <a:r>
              <a:rPr lang="en-US" altLang="zh-CN" sz="800" dirty="0" smtClean="0"/>
              <a:t>PRAD	Prostate adenocarcinoma</a:t>
            </a:r>
          </a:p>
          <a:p>
            <a:r>
              <a:rPr lang="en-US" altLang="zh-CN" sz="800" dirty="0" smtClean="0"/>
              <a:t>READ	Rectum adenocarcinoma</a:t>
            </a:r>
          </a:p>
          <a:p>
            <a:r>
              <a:rPr lang="en-US" altLang="zh-CN" sz="800" dirty="0" smtClean="0"/>
              <a:t>SARC	Sarcoma</a:t>
            </a:r>
          </a:p>
          <a:p>
            <a:r>
              <a:rPr lang="en-US" altLang="zh-CN" sz="800" dirty="0" smtClean="0"/>
              <a:t>SKCM	Skin Cutaneous Melanoma</a:t>
            </a:r>
          </a:p>
          <a:p>
            <a:r>
              <a:rPr lang="en-US" altLang="zh-CN" sz="800" dirty="0" smtClean="0"/>
              <a:t>STAD	Stomach adenocarcinoma</a:t>
            </a:r>
          </a:p>
          <a:p>
            <a:r>
              <a:rPr lang="en-US" altLang="zh-CN" sz="800" dirty="0" smtClean="0"/>
              <a:t>TGCT	Testicular Germ Cell Tumors</a:t>
            </a:r>
          </a:p>
          <a:p>
            <a:r>
              <a:rPr lang="en-US" altLang="zh-CN" sz="800" dirty="0" smtClean="0"/>
              <a:t>THCA	Thyroid carcinoma</a:t>
            </a:r>
          </a:p>
          <a:p>
            <a:r>
              <a:rPr lang="en-US" altLang="zh-CN" sz="800" dirty="0" smtClean="0"/>
              <a:t>THYM	</a:t>
            </a:r>
            <a:r>
              <a:rPr lang="en-US" altLang="zh-CN" sz="800" dirty="0" err="1" smtClean="0"/>
              <a:t>Thymoma</a:t>
            </a:r>
            <a:endParaRPr lang="en-US" altLang="zh-CN" sz="800" dirty="0" smtClean="0"/>
          </a:p>
          <a:p>
            <a:r>
              <a:rPr lang="en-US" altLang="zh-CN" sz="800" dirty="0" smtClean="0"/>
              <a:t>UCEC	Uterine Corpus Endometrial Carcinoma</a:t>
            </a:r>
          </a:p>
          <a:p>
            <a:r>
              <a:rPr lang="en-US" altLang="zh-CN" sz="800" dirty="0" smtClean="0"/>
              <a:t>UCS	Uterine </a:t>
            </a:r>
            <a:r>
              <a:rPr lang="en-US" altLang="zh-CN" sz="800" dirty="0" err="1" smtClean="0"/>
              <a:t>Carcinosarcoma</a:t>
            </a:r>
            <a:endParaRPr lang="en-US" altLang="zh-CN" sz="800" dirty="0" smtClean="0"/>
          </a:p>
          <a:p>
            <a:r>
              <a:rPr lang="en-US" altLang="zh-CN" sz="800" dirty="0" smtClean="0"/>
              <a:t>UVM	Uveal Melanoma</a:t>
            </a:r>
            <a:endParaRPr lang="en-US" altLang="zh-CN" sz="800" dirty="0"/>
          </a:p>
        </p:txBody>
      </p:sp>
      <p:sp>
        <p:nvSpPr>
          <p:cNvPr id="9" name="矩形 8"/>
          <p:cNvSpPr/>
          <p:nvPr/>
        </p:nvSpPr>
        <p:spPr>
          <a:xfrm>
            <a:off x="1618466" y="5978297"/>
            <a:ext cx="818999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/>
              <a:t>Supplementary Figure S1. </a:t>
            </a:r>
            <a:r>
              <a:rPr lang="en-US" altLang="zh-CN" sz="1200" dirty="0"/>
              <a:t>T</a:t>
            </a:r>
            <a:r>
              <a:rPr lang="en-US" altLang="zh-CN" sz="1200" dirty="0" smtClean="0"/>
              <a:t>issue-wise expression of </a:t>
            </a:r>
            <a:r>
              <a:rPr lang="en-US" altLang="zh-CN" sz="1200" i="1" dirty="0" smtClean="0"/>
              <a:t>CCNE1</a:t>
            </a:r>
            <a:r>
              <a:rPr lang="en-US" altLang="zh-CN" sz="1200" dirty="0" smtClean="0"/>
              <a:t> in different cancer types by GEPIA 2 website based on TCGA datasets.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7602053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8012494"/>
              </p:ext>
            </p:extLst>
          </p:nvPr>
        </p:nvGraphicFramePr>
        <p:xfrm>
          <a:off x="1038791" y="971432"/>
          <a:ext cx="6800850" cy="44624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文本框 4"/>
          <p:cNvSpPr txBox="1"/>
          <p:nvPr/>
        </p:nvSpPr>
        <p:spPr>
          <a:xfrm rot="16200000">
            <a:off x="-941298" y="2797522"/>
            <a:ext cx="3438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old change (Tumor/Normal, TPM)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4059948" y="375811"/>
            <a:ext cx="63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 smtClean="0"/>
              <a:t>E2F1</a:t>
            </a:r>
            <a:endParaRPr lang="zh-CN" altLang="en-US" i="1" dirty="0"/>
          </a:p>
        </p:txBody>
      </p:sp>
      <p:sp>
        <p:nvSpPr>
          <p:cNvPr id="8" name="矩形 7"/>
          <p:cNvSpPr/>
          <p:nvPr/>
        </p:nvSpPr>
        <p:spPr>
          <a:xfrm>
            <a:off x="8183417" y="1233597"/>
            <a:ext cx="5879631" cy="4154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00" dirty="0" smtClean="0"/>
              <a:t>ACC	Adrenocortical carcinoma</a:t>
            </a:r>
          </a:p>
          <a:p>
            <a:r>
              <a:rPr lang="en-US" altLang="zh-CN" sz="800" dirty="0" smtClean="0"/>
              <a:t>BLCA	Bladder Urothelial Carcinoma</a:t>
            </a:r>
          </a:p>
          <a:p>
            <a:r>
              <a:rPr lang="en-US" altLang="zh-CN" sz="800" dirty="0" smtClean="0"/>
              <a:t>BRCA	Breast invasive carcinoma</a:t>
            </a:r>
          </a:p>
          <a:p>
            <a:r>
              <a:rPr lang="en-US" altLang="zh-CN" sz="800" dirty="0" smtClean="0"/>
              <a:t>CESC	Cervical squamous cell carcinoma and </a:t>
            </a:r>
            <a:r>
              <a:rPr lang="en-US" altLang="zh-CN" sz="800" dirty="0" err="1" smtClean="0"/>
              <a:t>endocervical</a:t>
            </a:r>
            <a:r>
              <a:rPr lang="en-US" altLang="zh-CN" sz="800" dirty="0" smtClean="0"/>
              <a:t> adenocarcinoma</a:t>
            </a:r>
          </a:p>
          <a:p>
            <a:r>
              <a:rPr lang="en-US" altLang="zh-CN" sz="800" dirty="0" smtClean="0"/>
              <a:t>CHOL	</a:t>
            </a:r>
            <a:r>
              <a:rPr lang="en-US" altLang="zh-CN" sz="800" dirty="0" err="1" smtClean="0"/>
              <a:t>Cholangio</a:t>
            </a:r>
            <a:r>
              <a:rPr lang="en-US" altLang="zh-CN" sz="800" dirty="0" smtClean="0"/>
              <a:t> carcinoma</a:t>
            </a:r>
          </a:p>
          <a:p>
            <a:r>
              <a:rPr lang="en-US" altLang="zh-CN" sz="800" dirty="0" smtClean="0"/>
              <a:t>COAD	Colon adenocarcinoma</a:t>
            </a:r>
          </a:p>
          <a:p>
            <a:r>
              <a:rPr lang="en-US" altLang="zh-CN" sz="800" dirty="0" smtClean="0"/>
              <a:t>DLBC	Lymphoid Neoplasm Diffuse Large B-cell Lymphoma</a:t>
            </a:r>
          </a:p>
          <a:p>
            <a:r>
              <a:rPr lang="en-US" altLang="zh-CN" sz="800" dirty="0" smtClean="0"/>
              <a:t>ESCA	Esophageal carcinoma</a:t>
            </a:r>
          </a:p>
          <a:p>
            <a:r>
              <a:rPr lang="en-US" altLang="zh-CN" sz="800" dirty="0" smtClean="0"/>
              <a:t>GBM	Glioblastoma </a:t>
            </a:r>
            <a:r>
              <a:rPr lang="en-US" altLang="zh-CN" sz="800" dirty="0" err="1" smtClean="0"/>
              <a:t>multiforme</a:t>
            </a:r>
            <a:endParaRPr lang="en-US" altLang="zh-CN" sz="800" dirty="0" smtClean="0"/>
          </a:p>
          <a:p>
            <a:r>
              <a:rPr lang="en-US" altLang="zh-CN" sz="800" dirty="0" smtClean="0"/>
              <a:t>HNSC	Head and Neck squamous cell carcinoma</a:t>
            </a:r>
          </a:p>
          <a:p>
            <a:r>
              <a:rPr lang="en-US" altLang="zh-CN" sz="800" dirty="0" smtClean="0"/>
              <a:t>KICH	Kidney </a:t>
            </a:r>
            <a:r>
              <a:rPr lang="en-US" altLang="zh-CN" sz="800" dirty="0" err="1" smtClean="0"/>
              <a:t>Chromophobe</a:t>
            </a:r>
            <a:endParaRPr lang="en-US" altLang="zh-CN" sz="800" dirty="0" smtClean="0"/>
          </a:p>
          <a:p>
            <a:r>
              <a:rPr lang="en-US" altLang="zh-CN" sz="800" dirty="0" smtClean="0"/>
              <a:t>KIRC	Kidney renal clear cell carcinoma</a:t>
            </a:r>
          </a:p>
          <a:p>
            <a:r>
              <a:rPr lang="en-US" altLang="zh-CN" sz="800" dirty="0" smtClean="0"/>
              <a:t>KIRP	Kidney renal papillary cell carcinoma</a:t>
            </a:r>
          </a:p>
          <a:p>
            <a:r>
              <a:rPr lang="en-US" altLang="zh-CN" sz="800" dirty="0" smtClean="0"/>
              <a:t>LAML	Acute Myeloid Leukemia</a:t>
            </a:r>
          </a:p>
          <a:p>
            <a:r>
              <a:rPr lang="en-US" altLang="zh-CN" sz="800" dirty="0" smtClean="0"/>
              <a:t>LGG	Brain Lower Grade Glioma</a:t>
            </a:r>
          </a:p>
          <a:p>
            <a:r>
              <a:rPr lang="en-US" altLang="zh-CN" sz="800" dirty="0" smtClean="0"/>
              <a:t>LIHC	Liver hepatocellular carcinoma</a:t>
            </a:r>
          </a:p>
          <a:p>
            <a:r>
              <a:rPr lang="en-US" altLang="zh-CN" sz="800" dirty="0" smtClean="0"/>
              <a:t>LUAD	Lung adenocarcinoma</a:t>
            </a:r>
          </a:p>
          <a:p>
            <a:r>
              <a:rPr lang="en-US" altLang="zh-CN" sz="800" dirty="0" smtClean="0"/>
              <a:t>LUSC	Lung squamous cell carcinoma</a:t>
            </a:r>
          </a:p>
          <a:p>
            <a:r>
              <a:rPr lang="en-US" altLang="zh-CN" sz="800" dirty="0" smtClean="0"/>
              <a:t>MESO	Mesothelioma</a:t>
            </a:r>
          </a:p>
          <a:p>
            <a:r>
              <a:rPr lang="en-US" altLang="zh-CN" sz="800" dirty="0" smtClean="0"/>
              <a:t>OV	Ovarian serous cystadenocarcinoma</a:t>
            </a:r>
          </a:p>
          <a:p>
            <a:r>
              <a:rPr lang="en-US" altLang="zh-CN" sz="800" dirty="0" smtClean="0"/>
              <a:t>PAAD	Pancreatic adenocarcinoma</a:t>
            </a:r>
          </a:p>
          <a:p>
            <a:r>
              <a:rPr lang="en-US" altLang="zh-CN" sz="800" dirty="0" smtClean="0"/>
              <a:t>PCPG	</a:t>
            </a:r>
            <a:r>
              <a:rPr lang="en-US" altLang="zh-CN" sz="800" dirty="0" err="1" smtClean="0"/>
              <a:t>Pheochromocytoma</a:t>
            </a:r>
            <a:r>
              <a:rPr lang="en-US" altLang="zh-CN" sz="800" dirty="0" smtClean="0"/>
              <a:t> and </a:t>
            </a:r>
            <a:r>
              <a:rPr lang="en-US" altLang="zh-CN" sz="800" dirty="0" err="1" smtClean="0"/>
              <a:t>Paraganglioma</a:t>
            </a:r>
            <a:endParaRPr lang="en-US" altLang="zh-CN" sz="800" dirty="0" smtClean="0"/>
          </a:p>
          <a:p>
            <a:r>
              <a:rPr lang="en-US" altLang="zh-CN" sz="800" dirty="0" smtClean="0"/>
              <a:t>PRAD	Prostate adenocarcinoma</a:t>
            </a:r>
          </a:p>
          <a:p>
            <a:r>
              <a:rPr lang="en-US" altLang="zh-CN" sz="800" dirty="0" smtClean="0"/>
              <a:t>READ	Rectum adenocarcinoma</a:t>
            </a:r>
          </a:p>
          <a:p>
            <a:r>
              <a:rPr lang="en-US" altLang="zh-CN" sz="800" dirty="0" smtClean="0"/>
              <a:t>SARC	Sarcoma</a:t>
            </a:r>
          </a:p>
          <a:p>
            <a:r>
              <a:rPr lang="en-US" altLang="zh-CN" sz="800" dirty="0" smtClean="0"/>
              <a:t>SKCM	Skin Cutaneous Melanoma</a:t>
            </a:r>
          </a:p>
          <a:p>
            <a:r>
              <a:rPr lang="en-US" altLang="zh-CN" sz="800" dirty="0" smtClean="0"/>
              <a:t>STAD	Stomach adenocarcinoma</a:t>
            </a:r>
          </a:p>
          <a:p>
            <a:r>
              <a:rPr lang="en-US" altLang="zh-CN" sz="800" dirty="0" smtClean="0"/>
              <a:t>TGCT	Testicular Germ Cell Tumors</a:t>
            </a:r>
          </a:p>
          <a:p>
            <a:r>
              <a:rPr lang="en-US" altLang="zh-CN" sz="800" dirty="0" smtClean="0"/>
              <a:t>THCA	Thyroid carcinoma</a:t>
            </a:r>
          </a:p>
          <a:p>
            <a:r>
              <a:rPr lang="en-US" altLang="zh-CN" sz="800" dirty="0" smtClean="0"/>
              <a:t>THYM	</a:t>
            </a:r>
            <a:r>
              <a:rPr lang="en-US" altLang="zh-CN" sz="800" dirty="0" err="1" smtClean="0"/>
              <a:t>Thymoma</a:t>
            </a:r>
            <a:endParaRPr lang="en-US" altLang="zh-CN" sz="800" dirty="0" smtClean="0"/>
          </a:p>
          <a:p>
            <a:r>
              <a:rPr lang="en-US" altLang="zh-CN" sz="800" dirty="0" smtClean="0"/>
              <a:t>UCEC	Uterine Corpus Endometrial Carcinoma</a:t>
            </a:r>
          </a:p>
          <a:p>
            <a:r>
              <a:rPr lang="en-US" altLang="zh-CN" sz="800" dirty="0" smtClean="0"/>
              <a:t>UCS	Uterine </a:t>
            </a:r>
            <a:r>
              <a:rPr lang="en-US" altLang="zh-CN" sz="800" dirty="0" err="1" smtClean="0"/>
              <a:t>Carcinosarcoma</a:t>
            </a:r>
            <a:endParaRPr lang="en-US" altLang="zh-CN" sz="800" dirty="0" smtClean="0"/>
          </a:p>
          <a:p>
            <a:r>
              <a:rPr lang="en-US" altLang="zh-CN" sz="800" dirty="0" smtClean="0"/>
              <a:t>UVM	Uveal Melanoma</a:t>
            </a:r>
            <a:endParaRPr lang="en-US" altLang="zh-CN" sz="800" dirty="0"/>
          </a:p>
        </p:txBody>
      </p:sp>
      <p:sp>
        <p:nvSpPr>
          <p:cNvPr id="9" name="矩形 8"/>
          <p:cNvSpPr/>
          <p:nvPr/>
        </p:nvSpPr>
        <p:spPr>
          <a:xfrm>
            <a:off x="1618466" y="5978297"/>
            <a:ext cx="80761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/>
              <a:t>Supplementary Figure S2. Tissue-wise expression of </a:t>
            </a:r>
            <a:r>
              <a:rPr lang="en-US" altLang="zh-CN" sz="1200" i="1" dirty="0" smtClean="0"/>
              <a:t>E2F1</a:t>
            </a:r>
            <a:r>
              <a:rPr lang="en-US" altLang="zh-CN" sz="1200" dirty="0" smtClean="0"/>
              <a:t> in different cancer types by GEPIA 2 website based on TCGA datasets.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4100011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矩形 8"/>
          <p:cNvSpPr/>
          <p:nvPr/>
        </p:nvSpPr>
        <p:spPr>
          <a:xfrm>
            <a:off x="1198210" y="5409598"/>
            <a:ext cx="938862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dirty="0"/>
              <a:t>Supplementary Figure </a:t>
            </a:r>
            <a:r>
              <a:rPr lang="en-US" altLang="zh-CN" sz="1200" dirty="0" smtClean="0"/>
              <a:t>S3. </a:t>
            </a:r>
            <a:r>
              <a:rPr lang="en-US" altLang="zh-CN" sz="1200" dirty="0"/>
              <a:t>Correlation analysis of DNA methylation level and transcript level of </a:t>
            </a:r>
            <a:r>
              <a:rPr lang="en-US" altLang="zh-CN" sz="1200" i="1" dirty="0" smtClean="0"/>
              <a:t>CCNE1</a:t>
            </a:r>
            <a:r>
              <a:rPr lang="en-US" altLang="zh-CN" sz="1200" dirty="0" smtClean="0"/>
              <a:t> </a:t>
            </a:r>
            <a:r>
              <a:rPr lang="en-US" altLang="zh-CN" sz="1200" dirty="0"/>
              <a:t>in 370 lung squamous cell carcinoma (A) and 456 </a:t>
            </a:r>
            <a:r>
              <a:rPr lang="en-US" altLang="zh-CN" sz="1200" dirty="0" smtClean="0"/>
              <a:t>lung </a:t>
            </a:r>
            <a:r>
              <a:rPr lang="en-US" altLang="zh-CN" sz="1200" dirty="0"/>
              <a:t>adenocarcinoma (B) </a:t>
            </a:r>
            <a:r>
              <a:rPr lang="en-US" altLang="zh-CN" sz="1200" dirty="0" smtClean="0"/>
              <a:t>tissues </a:t>
            </a:r>
            <a:r>
              <a:rPr lang="en-US" altLang="zh-CN" sz="1200" dirty="0"/>
              <a:t>from TCGA cohort by </a:t>
            </a:r>
            <a:r>
              <a:rPr lang="en-US" altLang="zh-CN" sz="1200" dirty="0" err="1"/>
              <a:t>cBioPortal</a:t>
            </a:r>
            <a:r>
              <a:rPr lang="en-US" altLang="zh-CN" sz="1200" dirty="0" smtClean="0"/>
              <a:t>.</a:t>
            </a:r>
            <a:endParaRPr lang="zh-CN" altLang="en-US" sz="1200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8210" y="224751"/>
            <a:ext cx="9128543" cy="49357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69189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矩形 7"/>
          <p:cNvSpPr/>
          <p:nvPr/>
        </p:nvSpPr>
        <p:spPr>
          <a:xfrm>
            <a:off x="1057293" y="5862266"/>
            <a:ext cx="938862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dirty="0"/>
              <a:t>Supplementary Figure </a:t>
            </a:r>
            <a:r>
              <a:rPr lang="en-US" altLang="zh-CN" sz="1200" dirty="0" smtClean="0"/>
              <a:t>S4. Correlation </a:t>
            </a:r>
            <a:r>
              <a:rPr lang="en-US" altLang="zh-CN" sz="1200" dirty="0"/>
              <a:t>analysis of DNA methylation level and transcript level </a:t>
            </a:r>
            <a:r>
              <a:rPr lang="en-US" altLang="zh-CN" sz="1200" dirty="0" smtClean="0"/>
              <a:t>of </a:t>
            </a:r>
            <a:r>
              <a:rPr lang="en-US" altLang="zh-CN" sz="1200" i="1" dirty="0" smtClean="0"/>
              <a:t>E2F1</a:t>
            </a:r>
            <a:r>
              <a:rPr lang="en-US" altLang="zh-CN" sz="1200" dirty="0" smtClean="0"/>
              <a:t> in 370 lung </a:t>
            </a:r>
            <a:r>
              <a:rPr lang="en-US" altLang="zh-CN" sz="1200" dirty="0"/>
              <a:t>squamous cell </a:t>
            </a:r>
            <a:r>
              <a:rPr lang="en-US" altLang="zh-CN" sz="1200" dirty="0" smtClean="0"/>
              <a:t>carcinoma (A) and 456 </a:t>
            </a:r>
            <a:r>
              <a:rPr lang="en-US" altLang="zh-CN" sz="1200" dirty="0"/>
              <a:t>Lung </a:t>
            </a:r>
            <a:r>
              <a:rPr lang="en-US" altLang="zh-CN" sz="1200" dirty="0" smtClean="0"/>
              <a:t>adenocarcinoma (B) </a:t>
            </a:r>
            <a:r>
              <a:rPr lang="en-US" altLang="zh-CN" sz="1200" dirty="0"/>
              <a:t>tissues </a:t>
            </a:r>
            <a:r>
              <a:rPr lang="en-US" altLang="zh-CN" sz="1200" dirty="0" smtClean="0"/>
              <a:t>from </a:t>
            </a:r>
            <a:r>
              <a:rPr lang="en-US" altLang="zh-CN" sz="1200" dirty="0"/>
              <a:t>TCGA </a:t>
            </a:r>
            <a:r>
              <a:rPr lang="en-US" altLang="zh-CN" sz="1200" dirty="0" smtClean="0"/>
              <a:t>cohort by </a:t>
            </a:r>
            <a:r>
              <a:rPr lang="en-US" altLang="zh-CN" sz="1200" dirty="0" err="1" smtClean="0"/>
              <a:t>cBioPortal</a:t>
            </a:r>
            <a:r>
              <a:rPr lang="en-US" altLang="zh-CN" sz="1200" dirty="0"/>
              <a:t>.</a:t>
            </a:r>
            <a:endParaRPr lang="zh-CN" altLang="en-US" sz="1200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293" y="463094"/>
            <a:ext cx="9382381" cy="50142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47425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1629991" y="6072253"/>
            <a:ext cx="87724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dirty="0"/>
              <a:t>Supplementary Figure </a:t>
            </a:r>
            <a:r>
              <a:rPr lang="en-US" altLang="zh-CN" sz="1200" dirty="0" smtClean="0"/>
              <a:t>S5. </a:t>
            </a:r>
            <a:r>
              <a:rPr lang="en-US" altLang="zh-CN" sz="1200" i="1" dirty="0" smtClean="0"/>
              <a:t>CCNE1 </a:t>
            </a:r>
            <a:r>
              <a:rPr lang="en-US" altLang="zh-CN" sz="1200" dirty="0" smtClean="0"/>
              <a:t>(A)</a:t>
            </a:r>
            <a:r>
              <a:rPr lang="en-US" altLang="zh-CN" sz="1200" i="1" dirty="0" smtClean="0"/>
              <a:t>, E2F1 </a:t>
            </a:r>
            <a:r>
              <a:rPr lang="en-US" altLang="zh-CN" sz="1200" dirty="0" smtClean="0"/>
              <a:t>(B)</a:t>
            </a:r>
            <a:r>
              <a:rPr lang="en-US" altLang="zh-CN" sz="1200" i="1" dirty="0" smtClean="0"/>
              <a:t>, ARHGAP11A </a:t>
            </a:r>
            <a:r>
              <a:rPr lang="en-US" altLang="zh-CN" sz="1200" dirty="0" smtClean="0"/>
              <a:t>(C)</a:t>
            </a:r>
            <a:r>
              <a:rPr lang="en-US" altLang="zh-CN" sz="1200" i="1" dirty="0" smtClean="0"/>
              <a:t>, RUNX1T1 </a:t>
            </a:r>
            <a:r>
              <a:rPr lang="en-US" altLang="zh-CN" sz="1200" dirty="0" smtClean="0"/>
              <a:t>(D) </a:t>
            </a:r>
            <a:r>
              <a:rPr lang="en-US" altLang="zh-CN" sz="1200" i="1" dirty="0"/>
              <a:t>and </a:t>
            </a:r>
            <a:r>
              <a:rPr lang="en-US" altLang="zh-CN" sz="1200" i="1" dirty="0" smtClean="0"/>
              <a:t>FES </a:t>
            </a:r>
            <a:r>
              <a:rPr lang="en-US" altLang="zh-CN" sz="1200" dirty="0" smtClean="0"/>
              <a:t>(E) stage plot in NSCLC tissues (</a:t>
            </a:r>
            <a:r>
              <a:rPr lang="en-US" altLang="zh-CN" sz="1200" dirty="0"/>
              <a:t>486 lung squamous cell carcinoma  and 483 </a:t>
            </a:r>
            <a:r>
              <a:rPr lang="en-US" altLang="zh-CN" sz="1200" dirty="0" smtClean="0"/>
              <a:t>lung </a:t>
            </a:r>
            <a:r>
              <a:rPr lang="en-US" altLang="zh-CN" sz="1200" dirty="0" smtClean="0"/>
              <a:t>adenocarcinoma </a:t>
            </a:r>
            <a:r>
              <a:rPr lang="en-US" altLang="zh-CN" sz="1200" dirty="0"/>
              <a:t>)  from TCGA </a:t>
            </a:r>
            <a:r>
              <a:rPr lang="en-US" altLang="zh-CN" sz="1200" dirty="0" smtClean="0"/>
              <a:t>cohort by GEPIA2.</a:t>
            </a:r>
            <a:endParaRPr lang="zh-CN" altLang="en-US" sz="1200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1393" y="343675"/>
            <a:ext cx="8981038" cy="5519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3336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9</TotalTime>
  <Words>183</Words>
  <Application>Microsoft Office PowerPoint</Application>
  <PresentationFormat>宽屏</PresentationFormat>
  <Paragraphs>75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Lihui</dc:creator>
  <cp:lastModifiedBy>Wang Lihui</cp:lastModifiedBy>
  <cp:revision>28</cp:revision>
  <dcterms:created xsi:type="dcterms:W3CDTF">2020-09-28T08:48:56Z</dcterms:created>
  <dcterms:modified xsi:type="dcterms:W3CDTF">2020-12-31T05:26:52Z</dcterms:modified>
</cp:coreProperties>
</file>